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7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4134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39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6778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6546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6461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661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5828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839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2272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8182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6399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3B502-0B00-46C1-A0C5-0707C720033E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AED05-C9D1-47DD-942C-8F8855F6E3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5241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600" y="228600"/>
            <a:ext cx="5615152" cy="5615152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1933912" y="6074979"/>
            <a:ext cx="84608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01.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stogram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enomic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eritability (h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)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alues of the 955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C-MS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eatures significantly associated to at least one reference SNP.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791326" y="2512194"/>
            <a:ext cx="346510" cy="9047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Rectangle 1"/>
          <p:cNvSpPr/>
          <p:nvPr/>
        </p:nvSpPr>
        <p:spPr>
          <a:xfrm rot="16200000">
            <a:off x="1566331" y="2995448"/>
            <a:ext cx="2628292" cy="2935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 of LC-MS </a:t>
            </a:r>
            <a:r>
              <a:rPr lang="fr-FR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endParaRPr lang="fr-FR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91552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1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o Moroldo</dc:creator>
  <cp:lastModifiedBy>Marco Moroldo</cp:lastModifiedBy>
  <cp:revision>7</cp:revision>
  <dcterms:created xsi:type="dcterms:W3CDTF">2023-06-12T13:16:25Z</dcterms:created>
  <dcterms:modified xsi:type="dcterms:W3CDTF">2023-06-16T13:25:08Z</dcterms:modified>
</cp:coreProperties>
</file>